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3A818-60D6-4C9E-976D-FDA772FBB9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A0128-7AE2-45CA-8371-26C9B618AB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AF95D-D5EB-4B64-8919-8E25B3E88E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78813-5794-45EF-9360-6DFD6396CA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FD0E1-8383-4C0D-BC7F-5637ED60CB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4C54E-E6C1-4F99-A6F3-51A88EAA45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554E1-FD2E-4BF4-93C9-93D3BD7516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8C69D-9F8C-4087-9DE0-4664062408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42964-2310-4967-8765-CD84C0986B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92146-4767-4674-83FA-8DD6B94A7C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6747B-6EA5-43AD-A998-A50C2CEB08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4A475-41C2-4C88-9513-28FC432516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CBEA58-CD86-444B-81CC-13A12952516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1120" y="647640"/>
            <a:ext cx="5462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u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S4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onal immunoglubulin heavy chain gene rearrangements in the EBER1 tumou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564200" y="1327320"/>
            <a:ext cx="3139920" cy="2836800"/>
            <a:chOff x="1564200" y="1327320"/>
            <a:chExt cx="3139920" cy="2836800"/>
          </a:xfrm>
        </p:grpSpPr>
        <p:sp>
          <p:nvSpPr>
            <p:cNvPr id="43" name=""/>
            <p:cNvSpPr/>
            <p:nvPr/>
          </p:nvSpPr>
          <p:spPr>
            <a:xfrm>
              <a:off x="2079000" y="1805040"/>
              <a:ext cx="262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SC    S    MLN    S    MLN   S    ML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581200" y="1801800"/>
              <a:ext cx="609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602800" y="147636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-my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283920" y="1327320"/>
              <a:ext cx="646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BER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27.49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984120" y="1327320"/>
              <a:ext cx="646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BER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27.3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564200" y="269244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857240" y="2841480"/>
              <a:ext cx="255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76720" y="180180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989520" y="180180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2" name="" descr=""/>
            <p:cNvPicPr/>
            <p:nvPr/>
          </p:nvPicPr>
          <p:blipFill>
            <a:blip r:embed="rId1"/>
            <a:srcRect l="0" t="0" r="0" b="22780"/>
            <a:stretch/>
          </p:blipFill>
          <p:spPr>
            <a:xfrm>
              <a:off x="2138400" y="2084400"/>
              <a:ext cx="2468520" cy="207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2478240" y="2668680"/>
              <a:ext cx="74520" cy="6804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" bIns="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78240" y="2509920"/>
              <a:ext cx="74520" cy="6804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" bIns="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201840" y="2901960"/>
              <a:ext cx="74880" cy="6840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" bIns="2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538440" y="2901960"/>
              <a:ext cx="74880" cy="6840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" bIns="2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840040" y="2509920"/>
              <a:ext cx="74520" cy="6804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" bIns="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868560" y="3500280"/>
              <a:ext cx="74880" cy="6840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" bIns="2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840040" y="2668680"/>
              <a:ext cx="74520" cy="6804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" bIns="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855960" y="2668680"/>
              <a:ext cx="74520" cy="6804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" bIns="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211640" y="2668680"/>
              <a:ext cx="74520" cy="6804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" bIns="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211640" y="3500280"/>
              <a:ext cx="74520" cy="68400"/>
            </a:xfrm>
            <a:prstGeom prst="ellipse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" bIns="2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6T15:35:40Z</dcterms:created>
  <dc:creator>Joanna B. Wilson</dc:creator>
  <dc:description/>
  <dc:language>en-US</dc:language>
  <cp:lastModifiedBy>Joanna Wilson</cp:lastModifiedBy>
  <cp:lastPrinted>2006-10-24T23:40:24Z</cp:lastPrinted>
  <dcterms:modified xsi:type="dcterms:W3CDTF">2010-01-18T17:03:36Z</dcterms:modified>
  <cp:revision>74</cp:revision>
  <dc:subject/>
  <dc:title>PowerPoint Presentation</dc:title>
</cp:coreProperties>
</file>